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0" autoAdjust="0"/>
    <p:restoredTop sz="94660"/>
  </p:normalViewPr>
  <p:slideViewPr>
    <p:cSldViewPr snapToGrid="0">
      <p:cViewPr varScale="1">
        <p:scale>
          <a:sx n="63" d="100"/>
          <a:sy n="63" d="100"/>
        </p:scale>
        <p:origin x="688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iaco\Desktop\genalex%20su%2037%20genotipi-definitivo_12nov2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7613308841571392E-2"/>
          <c:y val="4.5211672831894777E-2"/>
          <c:w val="0.87695903140697007"/>
          <c:h val="0.7966284661054954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FF"/>
            </a:solidFill>
            <a:ln>
              <a:noFill/>
            </a:ln>
            <a:effectLst/>
          </c:spPr>
          <c:invertIfNegative val="0"/>
          <c:cat>
            <c:strRef>
              <c:f>'Grafico alleli privati '!$K$20:$X$20</c:f>
              <c:strCache>
                <c:ptCount val="14"/>
                <c:pt idx="0">
                  <c:v>1A</c:v>
                </c:pt>
                <c:pt idx="1">
                  <c:v>1B</c:v>
                </c:pt>
                <c:pt idx="2">
                  <c:v>2A</c:v>
                </c:pt>
                <c:pt idx="3">
                  <c:v>2B</c:v>
                </c:pt>
                <c:pt idx="4">
                  <c:v>3A</c:v>
                </c:pt>
                <c:pt idx="5">
                  <c:v>3B</c:v>
                </c:pt>
                <c:pt idx="6">
                  <c:v>4A</c:v>
                </c:pt>
                <c:pt idx="7">
                  <c:v>4B</c:v>
                </c:pt>
                <c:pt idx="8">
                  <c:v>5A</c:v>
                </c:pt>
                <c:pt idx="9">
                  <c:v>5B</c:v>
                </c:pt>
                <c:pt idx="10">
                  <c:v>6A</c:v>
                </c:pt>
                <c:pt idx="11">
                  <c:v>6B</c:v>
                </c:pt>
                <c:pt idx="12">
                  <c:v>7A</c:v>
                </c:pt>
                <c:pt idx="13">
                  <c:v>7B</c:v>
                </c:pt>
              </c:strCache>
            </c:strRef>
          </c:cat>
          <c:val>
            <c:numRef>
              <c:f>'Grafico alleli privati '!$K$21:$X$21</c:f>
              <c:numCache>
                <c:formatCode>General</c:formatCode>
                <c:ptCount val="14"/>
                <c:pt idx="0">
                  <c:v>35</c:v>
                </c:pt>
                <c:pt idx="1">
                  <c:v>60</c:v>
                </c:pt>
                <c:pt idx="2">
                  <c:v>37</c:v>
                </c:pt>
                <c:pt idx="3">
                  <c:v>49</c:v>
                </c:pt>
                <c:pt idx="4">
                  <c:v>27</c:v>
                </c:pt>
                <c:pt idx="5">
                  <c:v>38</c:v>
                </c:pt>
                <c:pt idx="6">
                  <c:v>29</c:v>
                </c:pt>
                <c:pt idx="7">
                  <c:v>34</c:v>
                </c:pt>
                <c:pt idx="8">
                  <c:v>44</c:v>
                </c:pt>
                <c:pt idx="9">
                  <c:v>32</c:v>
                </c:pt>
                <c:pt idx="10">
                  <c:v>22</c:v>
                </c:pt>
                <c:pt idx="11">
                  <c:v>38</c:v>
                </c:pt>
                <c:pt idx="12">
                  <c:v>57</c:v>
                </c:pt>
                <c:pt idx="13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65-428A-AE66-7789E85BF1C2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solidFill>
                <a:schemeClr val="accent1"/>
              </a:solidFill>
            </a:ln>
            <a:effectLst/>
          </c:spPr>
          <c:invertIfNegative val="0"/>
          <c:cat>
            <c:strRef>
              <c:f>'Grafico alleli privati '!$K$20:$X$20</c:f>
              <c:strCache>
                <c:ptCount val="14"/>
                <c:pt idx="0">
                  <c:v>1A</c:v>
                </c:pt>
                <c:pt idx="1">
                  <c:v>1B</c:v>
                </c:pt>
                <c:pt idx="2">
                  <c:v>2A</c:v>
                </c:pt>
                <c:pt idx="3">
                  <c:v>2B</c:v>
                </c:pt>
                <c:pt idx="4">
                  <c:v>3A</c:v>
                </c:pt>
                <c:pt idx="5">
                  <c:v>3B</c:v>
                </c:pt>
                <c:pt idx="6">
                  <c:v>4A</c:v>
                </c:pt>
                <c:pt idx="7">
                  <c:v>4B</c:v>
                </c:pt>
                <c:pt idx="8">
                  <c:v>5A</c:v>
                </c:pt>
                <c:pt idx="9">
                  <c:v>5B</c:v>
                </c:pt>
                <c:pt idx="10">
                  <c:v>6A</c:v>
                </c:pt>
                <c:pt idx="11">
                  <c:v>6B</c:v>
                </c:pt>
                <c:pt idx="12">
                  <c:v>7A</c:v>
                </c:pt>
                <c:pt idx="13">
                  <c:v>7B</c:v>
                </c:pt>
              </c:strCache>
            </c:strRef>
          </c:cat>
          <c:val>
            <c:numRef>
              <c:f>'Grafico alleli privati '!$K$22:$X$22</c:f>
              <c:numCache>
                <c:formatCode>General</c:formatCode>
                <c:ptCount val="14"/>
                <c:pt idx="0">
                  <c:v>18</c:v>
                </c:pt>
                <c:pt idx="1">
                  <c:v>26</c:v>
                </c:pt>
                <c:pt idx="2">
                  <c:v>16</c:v>
                </c:pt>
                <c:pt idx="3">
                  <c:v>26</c:v>
                </c:pt>
                <c:pt idx="4">
                  <c:v>22</c:v>
                </c:pt>
                <c:pt idx="5">
                  <c:v>38</c:v>
                </c:pt>
                <c:pt idx="6">
                  <c:v>16</c:v>
                </c:pt>
                <c:pt idx="7">
                  <c:v>9</c:v>
                </c:pt>
                <c:pt idx="8">
                  <c:v>19</c:v>
                </c:pt>
                <c:pt idx="9">
                  <c:v>32</c:v>
                </c:pt>
                <c:pt idx="10">
                  <c:v>32</c:v>
                </c:pt>
                <c:pt idx="11">
                  <c:v>22</c:v>
                </c:pt>
                <c:pt idx="12">
                  <c:v>36</c:v>
                </c:pt>
                <c:pt idx="13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D65-428A-AE66-7789E85BF1C2}"/>
            </c:ext>
          </c:extLst>
        </c:ser>
        <c:ser>
          <c:idx val="2"/>
          <c:order val="2"/>
          <c:spPr>
            <a:solidFill>
              <a:schemeClr val="accent6"/>
            </a:solidFill>
            <a:ln>
              <a:solidFill>
                <a:schemeClr val="accent1"/>
              </a:solidFill>
            </a:ln>
            <a:effectLst/>
          </c:spPr>
          <c:invertIfNegative val="0"/>
          <c:cat>
            <c:strRef>
              <c:f>'Grafico alleli privati '!$K$20:$X$20</c:f>
              <c:strCache>
                <c:ptCount val="14"/>
                <c:pt idx="0">
                  <c:v>1A</c:v>
                </c:pt>
                <c:pt idx="1">
                  <c:v>1B</c:v>
                </c:pt>
                <c:pt idx="2">
                  <c:v>2A</c:v>
                </c:pt>
                <c:pt idx="3">
                  <c:v>2B</c:v>
                </c:pt>
                <c:pt idx="4">
                  <c:v>3A</c:v>
                </c:pt>
                <c:pt idx="5">
                  <c:v>3B</c:v>
                </c:pt>
                <c:pt idx="6">
                  <c:v>4A</c:v>
                </c:pt>
                <c:pt idx="7">
                  <c:v>4B</c:v>
                </c:pt>
                <c:pt idx="8">
                  <c:v>5A</c:v>
                </c:pt>
                <c:pt idx="9">
                  <c:v>5B</c:v>
                </c:pt>
                <c:pt idx="10">
                  <c:v>6A</c:v>
                </c:pt>
                <c:pt idx="11">
                  <c:v>6B</c:v>
                </c:pt>
                <c:pt idx="12">
                  <c:v>7A</c:v>
                </c:pt>
                <c:pt idx="13">
                  <c:v>7B</c:v>
                </c:pt>
              </c:strCache>
            </c:strRef>
          </c:cat>
          <c:val>
            <c:numRef>
              <c:f>'Grafico alleli privati '!$K$23:$X$23</c:f>
              <c:numCache>
                <c:formatCode>General</c:formatCode>
                <c:ptCount val="14"/>
                <c:pt idx="0">
                  <c:v>44</c:v>
                </c:pt>
                <c:pt idx="1">
                  <c:v>27</c:v>
                </c:pt>
                <c:pt idx="2">
                  <c:v>28</c:v>
                </c:pt>
                <c:pt idx="3">
                  <c:v>47</c:v>
                </c:pt>
                <c:pt idx="4">
                  <c:v>27</c:v>
                </c:pt>
                <c:pt idx="5">
                  <c:v>38</c:v>
                </c:pt>
                <c:pt idx="6">
                  <c:v>29</c:v>
                </c:pt>
                <c:pt idx="7">
                  <c:v>12</c:v>
                </c:pt>
                <c:pt idx="8">
                  <c:v>29</c:v>
                </c:pt>
                <c:pt idx="9">
                  <c:v>41</c:v>
                </c:pt>
                <c:pt idx="10">
                  <c:v>25</c:v>
                </c:pt>
                <c:pt idx="11">
                  <c:v>20</c:v>
                </c:pt>
                <c:pt idx="12">
                  <c:v>40</c:v>
                </c:pt>
                <c:pt idx="13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D65-428A-AE66-7789E85BF1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4"/>
        <c:axId val="332236191"/>
        <c:axId val="332230783"/>
      </c:barChart>
      <c:catAx>
        <c:axId val="33223619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400" b="1"/>
                  <a:t>Chromosome</a:t>
                </a:r>
              </a:p>
            </c:rich>
          </c:tx>
          <c:layout>
            <c:manualLayout>
              <c:xMode val="edge"/>
              <c:yMode val="edge"/>
              <c:x val="0.47750699851838907"/>
              <c:y val="0.908733911343695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332230783"/>
        <c:crossesAt val="0"/>
        <c:auto val="1"/>
        <c:lblAlgn val="ctr"/>
        <c:lblOffset val="100"/>
        <c:noMultiLvlLbl val="0"/>
      </c:catAx>
      <c:valAx>
        <c:axId val="33223078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400" b="1"/>
                  <a:t>Private Alleles (n°)</a:t>
                </a:r>
              </a:p>
            </c:rich>
          </c:tx>
          <c:layout>
            <c:manualLayout>
              <c:xMode val="edge"/>
              <c:yMode val="edge"/>
              <c:x val="2.5427646786870088E-2"/>
              <c:y val="0.245328181079707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3322361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55C560F-68A1-4E86-8372-7EA854233D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74CEECF-75A5-4E35-9159-4117E01C89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4137871-B6AA-4FDE-A792-636947275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84559A2-4852-4AC2-9203-12C116C2A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55AE658-AEAF-46C4-8F69-D5F2B4792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9925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AB6AE49-0570-44F6-B447-FDDE017963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4101ABC-A50E-4680-B152-5859939DBC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9724E40-CFA1-431E-9041-4EF7048F6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4A8F1E-126C-4D35-8C67-11F3AA5AE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9BC1CBC-B6A5-43A0-ABA8-E81AD5BDC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77492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5A4B3F7-F395-470D-AD36-854A833C7B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7E916AF-7E12-471E-869E-CA52964CC0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8E47E4E-F1A3-45B9-BC76-ABC78A935A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19D8B07-0201-410C-803F-42214ED83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010BD45-AD31-4388-89D8-E4E5F57D1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3770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21EF92C-2DBB-4464-A42D-F99F4EAFAE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581EE3D-8CBA-40D7-BFA8-45DF88BCBA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473EB01-687A-4D7E-880F-14EA0519E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FF69E4D-7E47-4C5D-9010-CC7E2E869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D50DF1-6047-4A74-AEA9-C709221EC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08800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70221FE-0784-48D6-B6BC-342631D7C6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D4ABFFF-9173-401C-B27E-0F811C7D1E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0FAFD02-005B-4AC3-92B4-50B27979ED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D326BBC-E5A8-4349-AC5D-6F1A62A48A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6A64E0E-A7F5-4657-BA0D-F5279EB1F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8396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98804D3-620D-48D1-BA9B-E0B815F620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F3389CD-5960-40BF-8D68-723643F860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8F7B5AD-002C-482A-912D-2FE025C722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2BDB7AE-C545-4C61-9BF8-EDA266399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97D19AE-7BD1-45AC-A81D-0AB0B296B1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AA3FC30-C33D-4AC1-9FFF-E7EA71BC4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660635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76100D-EFE8-4460-9F80-59C1021062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A6E6D2E-409E-49D0-9C13-413BB53F76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C09BC13-073E-453A-A34C-0AD857AAAA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BCC318DC-5D6D-4BFA-86BE-8F0BC55D0C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F7C46A5-3C90-4B28-994E-FB4E991505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838DC68-528B-4266-9C5D-B212D2607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284BF46E-BC77-470E-832D-95F8FE449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3596F72E-F906-47F6-89D6-B7130FF24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9661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7BF3391-F376-4675-B3F3-1DFC6D343D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058E7ED-E80A-47B8-A5CC-8B1A747EC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D58B70B7-B080-40CE-B569-38FA9B3C33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EDEE17F1-CCE6-48F9-9753-96DF083FC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083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0E6D708-DAED-4C64-905E-224CDC1C6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031DEC0-6635-4E9E-8D3E-0259E749B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C6515825-019A-4170-AA55-FC55DD203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6836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89184C3-569F-43B1-81F9-937A741C06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1116E08-15ED-4BFB-9D84-486E3FBD5F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F37B07B-6DDA-4E4E-845E-8771672ED9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7BF1438-352B-48E2-B82D-8C1190479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602477D-AF68-4D87-8C52-B85A4BD0C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177AA38-4ABB-451B-ACE4-EF14DFDD16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5400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3B44432-1719-41AD-B613-189F822A9F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DF86316A-0F41-412D-9FAB-6FBBBEAFA6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D676B2A-9211-4F03-9533-B4E8088D50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4DAAEA8-8165-4E28-BD60-D307971714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D51308C-45A9-4A50-BEE3-4A83742D7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64116C0-D388-46ED-BE57-A29C06772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79635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A5892BFD-0419-4596-9367-3296EACEF2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D7DD89E-FED2-4D30-A568-C40820E54B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673C617-2B42-4DCE-8D0C-6E7BC7593E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23207E-FA19-4E43-BE85-01CB76F2FBBF}" type="datetimeFigureOut">
              <a:rPr lang="it-IT" smtClean="0"/>
              <a:t>05/05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D62487E-8B60-4CEC-9B18-C3CA8B8192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3857D12-94BB-4EE4-AA41-3F5A982B1C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EF5E10-37D5-4119-844D-223C9449406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6071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/>
          <p:cNvGraphicFramePr>
            <a:graphicFrameLocks/>
          </p:cNvGraphicFramePr>
          <p:nvPr/>
        </p:nvGraphicFramePr>
        <p:xfrm>
          <a:off x="1366683" y="904568"/>
          <a:ext cx="9556955" cy="46604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asellaDiTesto 2"/>
          <p:cNvSpPr txBox="1"/>
          <p:nvPr/>
        </p:nvSpPr>
        <p:spPr>
          <a:xfrm>
            <a:off x="561975" y="5912075"/>
            <a:ext cx="11303453" cy="487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 distribution of private alleles found in the three groups defined by cluster analysis based on 5,555 SNPs. The private alleles of Modern Durum Cultivars (MDC), Tunisian Durum Landraces group 1 (TDL-1) and group 2 (TDL-2) are colored in blue, red and green, respectively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72929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>
            <a:extLst>
              <a:ext uri="{FF2B5EF4-FFF2-40B4-BE49-F238E27FC236}">
                <a16:creationId xmlns:a16="http://schemas.microsoft.com/office/drawing/2014/main" id="{19C4FF12-434F-427E-A6E1-525652044A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356592" y="5827199"/>
            <a:ext cx="9689846" cy="567716"/>
          </a:xfrm>
        </p:spPr>
        <p:txBody>
          <a:bodyPr>
            <a:noAutofit/>
          </a:bodyPr>
          <a:lstStyle/>
          <a:p>
            <a:pPr algn="just">
              <a:lnSpc>
                <a:spcPct val="100000"/>
              </a:lnSpc>
            </a:pP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it-I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ntary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2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a-chromosomal linkage disequilibrium (LD) distribution and decay plot (r2) calculated using the 5,555 SNPs.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9119" y="101600"/>
            <a:ext cx="8156153" cy="5725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25817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</TotalTime>
  <Words>89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</dc:creator>
  <cp:lastModifiedBy>Giacomo Mangini</cp:lastModifiedBy>
  <cp:revision>15</cp:revision>
  <dcterms:created xsi:type="dcterms:W3CDTF">2021-10-15T13:25:22Z</dcterms:created>
  <dcterms:modified xsi:type="dcterms:W3CDTF">2022-05-04T22:40:09Z</dcterms:modified>
</cp:coreProperties>
</file>